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9" r:id="rId2"/>
    <p:sldId id="327" r:id="rId3"/>
    <p:sldId id="328" r:id="rId4"/>
    <p:sldId id="270" r:id="rId5"/>
    <p:sldId id="268" r:id="rId6"/>
    <p:sldId id="272" r:id="rId7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9" y="3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52A4DA-0DCB-4B04-B081-AE2CA3AF34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F89876-02EC-49A0-8374-35533784DD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A971DF-BE76-418E-AB83-EAD6BF090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923B0F-05A0-4853-AA8A-728269488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C6E2DF-1930-43AD-847C-CAC27AD53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448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ABA585-D61F-410E-A162-B2B95DFB6A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EA46ED-EE1B-4A22-A111-2BE529E620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C82E34-6482-4EEF-B922-39BBF89A6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B890D7-3F71-4ED9-AD62-B0E34DB20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BC3014-55B1-4975-8434-750D91C81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856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63F6EF-222C-4D83-BCA4-C53FB74134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B77307-5FCA-42EC-9DC3-DC652EFF1D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4F833-03AB-4D3C-81F7-CBB0EEA36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865659-B6C0-4C4D-BE7B-DAD70F909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A92A90-BB5D-4D99-8868-CF9A73614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625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EB0247-FC0F-4478-8F86-75433AB79D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9A3319-48FC-4971-A525-DEE7C3FEF1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6727B9-A150-49C0-9123-2736FCF4F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D02368-0549-428A-AF74-9D9C2D155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D2581C-E806-438C-8EA1-CDA88CE4B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920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F2D69-BDA5-4AAB-8C83-DD2EB0E93B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4B8353-D996-43F3-A28A-AF96ADD63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40EFA4-DEBB-42CB-A32D-68763D9EF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A39279-3DE8-4CBF-983E-B97853B4C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84A94C-EB1A-4EEB-A1B2-611AE7F05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266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5AC78F-EB67-4A4D-8000-EC9417F0D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E17336-F611-49FA-83DD-A468F75876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34FA34-46CD-4DA2-B801-94BB4654BD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E1F2B0-C356-4D48-AE69-F949169DB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4E5A90-923D-414E-BC70-216D545CC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548505-D3E1-4B36-9744-233CF4BA5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049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2B7C04-3AE7-4786-8B13-0212288F76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ABB65D-8E7E-44C3-87F8-68264FDC0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29CD2C-56BC-471B-8682-28297E33AE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B7073C-E508-4C42-9EA6-01D4044A4B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C6B87A-4B34-4783-A3CD-CDA6987B76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7BB788-783E-45ED-89DD-1FAE3BB7F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F3212AA-6BB0-4317-B274-E7C64EBA1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773C7E-19E9-45D1-9180-D59C964B9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33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066BB8-41EB-4F8F-98D9-40570E3A42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B7AA48-C66A-4D45-B5D2-E8F3450D6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716887-389E-4390-A0E1-5B2972BC2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F72F53-7D16-44E4-8372-ADB6DE3DE1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520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CCE5A7-B9B1-4F0C-9CB2-3547AF097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437447-D210-40BF-8026-758A89217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3656CC-88B7-4D8F-AEA4-83C7EE6FA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589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04E215-8EC9-463A-809B-9A57AE0838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DD885A-5B64-4F98-B7C4-3A99F0A435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73C5EE-1C83-4EDC-89B5-953907D48A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BF4DFF-58AA-4CF3-AA6F-9F02B5E79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B858E4-0DB9-458A-92C3-9289C25B4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232321-DFB0-47B8-823F-55D408EA4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235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16E52-29AC-48F8-BBB8-BEBD4F8D3D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B4E36E-51A1-4121-9228-17E35B4E2F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AE483B-BD1A-41BA-94E4-E5C667DB99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001CC6-3EE0-4F60-B93B-751685DAF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CEE08E-F05B-4774-B713-57B6242B1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22E575-F974-424B-8A25-6BE98F7EA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594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94168F-BB58-4BFB-B3D5-BCBA8A64D0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88C879-D3BA-47BA-8294-18D46672B3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907075-F908-4866-A878-E57ECEF0CA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7599F-C01E-4EFA-A92B-19FC636EDF7D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906D1C-4996-4796-8934-8645FBAA38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6F9FFD-E4D0-4FBA-B316-67822D1593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77169E-FB60-439D-8F54-635EDDD4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463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15.png"/><Relationship Id="rId7" Type="http://schemas.openxmlformats.org/officeDocument/2006/relationships/image" Target="../media/image2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12" Type="http://schemas.openxmlformats.org/officeDocument/2006/relationships/image" Target="../media/image52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png"/><Relationship Id="rId11" Type="http://schemas.openxmlformats.org/officeDocument/2006/relationships/image" Target="../media/image51.png"/><Relationship Id="rId5" Type="http://schemas.openxmlformats.org/officeDocument/2006/relationships/image" Target="../media/image45.png"/><Relationship Id="rId10" Type="http://schemas.openxmlformats.org/officeDocument/2006/relationships/image" Target="../media/image50.png"/><Relationship Id="rId4" Type="http://schemas.openxmlformats.org/officeDocument/2006/relationships/image" Target="../media/image44.png"/><Relationship Id="rId9" Type="http://schemas.openxmlformats.org/officeDocument/2006/relationships/image" Target="../media/image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EB9EEB7-092A-4A79-A5CF-8BBE1BB4CC5C}"/>
              </a:ext>
            </a:extLst>
          </p:cNvPr>
          <p:cNvCxnSpPr>
            <a:cxnSpLocks/>
          </p:cNvCxnSpPr>
          <p:nvPr/>
        </p:nvCxnSpPr>
        <p:spPr>
          <a:xfrm>
            <a:off x="8498958" y="1595888"/>
            <a:ext cx="2675214" cy="1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2" name="Group 31">
            <a:extLst>
              <a:ext uri="{FF2B5EF4-FFF2-40B4-BE49-F238E27FC236}">
                <a16:creationId xmlns:a16="http://schemas.microsoft.com/office/drawing/2014/main" id="{2E64050B-3E3F-4C6B-A398-F662391E87F6}"/>
              </a:ext>
            </a:extLst>
          </p:cNvPr>
          <p:cNvGrpSpPr/>
          <p:nvPr/>
        </p:nvGrpSpPr>
        <p:grpSpPr>
          <a:xfrm>
            <a:off x="907312" y="1147056"/>
            <a:ext cx="10595125" cy="4899325"/>
            <a:chOff x="112233" y="1147056"/>
            <a:chExt cx="10812875" cy="484992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1B45F0B-404A-4BF6-AE7D-20F97C66B6B8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2233" y="2639055"/>
              <a:ext cx="1416871" cy="1641415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9FB0B70-852F-46E9-818B-1617F9FD3851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255050" y="1735792"/>
              <a:ext cx="1371600" cy="13716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8A223CF-00CC-43D8-B489-D1B4D54E9AC7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323890" y="3940317"/>
              <a:ext cx="1371600" cy="13716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D6E975C-EB35-49E2-BC5E-E5665143CACA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736562" y="1726475"/>
              <a:ext cx="1371600" cy="13716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8C00AA8-49B4-4161-9141-5EC07D3F5A34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755485" y="3902287"/>
              <a:ext cx="1371600" cy="13716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0B895B4-CD64-48B3-AED3-65A9F6165842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096000" y="1735792"/>
              <a:ext cx="1371600" cy="13716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53A81EE-433E-4ABB-961F-E63608FB57E1}"/>
                </a:ext>
              </a:extLst>
            </p:cNvPr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111188" y="3873296"/>
              <a:ext cx="1371600" cy="13716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1124FCB-A340-4F94-8689-36130E39378F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565350" y="1726475"/>
              <a:ext cx="1371600" cy="13716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2160BC8-C55C-40AE-A324-6CEC9E429FF2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529105" y="3873296"/>
              <a:ext cx="1371600" cy="13716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20C7BE00-C95D-4CC9-9EBE-D1CE13A7C791}"/>
                </a:ext>
              </a:extLst>
            </p:cNvPr>
            <p:cNvPicPr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37072" y="1726475"/>
              <a:ext cx="1371600" cy="13716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9CFB3B4-7D06-4CFA-8631-028FD68AD1C3}"/>
                </a:ext>
              </a:extLst>
            </p:cNvPr>
            <p:cNvPicPr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116702" y="3866654"/>
              <a:ext cx="1371600" cy="13716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852F947-E64F-4AE3-BC3C-144D51FB2904}"/>
                </a:ext>
              </a:extLst>
            </p:cNvPr>
            <p:cNvPicPr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606450" y="1735792"/>
              <a:ext cx="1371600" cy="13716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97B7C815-A061-4667-85FE-AA4E3EF8B370}"/>
                </a:ext>
              </a:extLst>
            </p:cNvPr>
            <p:cNvPicPr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544452" y="3915189"/>
              <a:ext cx="1371600" cy="1371600"/>
            </a:xfrm>
            <a:prstGeom prst="rect">
              <a:avLst/>
            </a:prstGeom>
          </p:spPr>
        </p:pic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6C8F658-5E43-46E3-9B7F-33A1CD6D1D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83834" y="3564136"/>
              <a:ext cx="9211656" cy="1881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D715DA6B-A46E-4672-8FBE-77C75ADFDE25}"/>
                </a:ext>
              </a:extLst>
            </p:cNvPr>
            <p:cNvCxnSpPr/>
            <p:nvPr/>
          </p:nvCxnSpPr>
          <p:spPr>
            <a:xfrm flipH="1">
              <a:off x="2385631" y="3267740"/>
              <a:ext cx="6666" cy="67630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14E5B450-FD47-4AF5-B320-08EFB277B7C0}"/>
                </a:ext>
              </a:extLst>
            </p:cNvPr>
            <p:cNvCxnSpPr/>
            <p:nvPr/>
          </p:nvCxnSpPr>
          <p:spPr>
            <a:xfrm flipH="1">
              <a:off x="3976971" y="3225985"/>
              <a:ext cx="6666" cy="67630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B58F7CD0-31DF-42AB-9524-406C1955529F}"/>
                </a:ext>
              </a:extLst>
            </p:cNvPr>
            <p:cNvCxnSpPr/>
            <p:nvPr/>
          </p:nvCxnSpPr>
          <p:spPr>
            <a:xfrm flipH="1">
              <a:off x="5366109" y="3234389"/>
              <a:ext cx="6666" cy="67630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2D5006AB-C998-42D5-8698-A2621C04CFD0}"/>
                </a:ext>
              </a:extLst>
            </p:cNvPr>
            <p:cNvCxnSpPr/>
            <p:nvPr/>
          </p:nvCxnSpPr>
          <p:spPr>
            <a:xfrm flipH="1">
              <a:off x="6915100" y="3225985"/>
              <a:ext cx="6666" cy="67630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10FE8AFC-F16B-4ACB-8A09-965981E751C8}"/>
                </a:ext>
              </a:extLst>
            </p:cNvPr>
            <p:cNvCxnSpPr/>
            <p:nvPr/>
          </p:nvCxnSpPr>
          <p:spPr>
            <a:xfrm flipH="1">
              <a:off x="8612766" y="3196176"/>
              <a:ext cx="6666" cy="67630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465DCCC5-3BB7-4CBB-9507-33F6105FEE6E}"/>
                </a:ext>
              </a:extLst>
            </p:cNvPr>
            <p:cNvCxnSpPr/>
            <p:nvPr/>
          </p:nvCxnSpPr>
          <p:spPr>
            <a:xfrm flipH="1">
              <a:off x="10126134" y="3234389"/>
              <a:ext cx="6666" cy="67630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934F6D1-D31B-4214-8496-120E9B42CAB3}"/>
                </a:ext>
              </a:extLst>
            </p:cNvPr>
            <p:cNvSpPr txBox="1"/>
            <p:nvPr/>
          </p:nvSpPr>
          <p:spPr>
            <a:xfrm>
              <a:off x="1713453" y="5658429"/>
              <a:ext cx="9211655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 Black" panose="020B0A04020102020204" pitchFamily="34" charset="0"/>
                </a:rPr>
                <a:t>Supplement Fig. 1 Gating Strategy for CD3, CD4, CD8, CD14, CD16 and CD2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0C4496D-7D41-46C8-B06A-D840C976EE75}"/>
                </a:ext>
              </a:extLst>
            </p:cNvPr>
            <p:cNvSpPr txBox="1"/>
            <p:nvPr/>
          </p:nvSpPr>
          <p:spPr>
            <a:xfrm>
              <a:off x="7982097" y="1147056"/>
              <a:ext cx="25459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            </a:t>
              </a:r>
              <a:r>
                <a:rPr lang="en-US" sz="1600" b="1" dirty="0">
                  <a:latin typeface="Arial Black" panose="020B0A04020102020204" pitchFamily="34" charset="0"/>
                </a:rPr>
                <a:t>Monocytes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38D1554C-334C-4398-83BF-281A99873AF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12335" y="1523297"/>
              <a:ext cx="5103628" cy="7259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4BCBA91-A660-4334-A447-87387DB61F85}"/>
                </a:ext>
              </a:extLst>
            </p:cNvPr>
            <p:cNvSpPr txBox="1"/>
            <p:nvPr/>
          </p:nvSpPr>
          <p:spPr>
            <a:xfrm>
              <a:off x="3839291" y="1156373"/>
              <a:ext cx="14879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Lymphocytes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FA3C079-7D54-46DC-ACEB-FCCBE6219548}"/>
                </a:ext>
              </a:extLst>
            </p:cNvPr>
            <p:cNvSpPr txBox="1"/>
            <p:nvPr/>
          </p:nvSpPr>
          <p:spPr>
            <a:xfrm>
              <a:off x="5490339" y="3234389"/>
              <a:ext cx="21204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Isotyp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24263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8ADD975-6699-4DE4-9590-5799B43AE27D}"/>
              </a:ext>
            </a:extLst>
          </p:cNvPr>
          <p:cNvCxnSpPr>
            <a:cxnSpLocks/>
          </p:cNvCxnSpPr>
          <p:nvPr/>
        </p:nvCxnSpPr>
        <p:spPr>
          <a:xfrm>
            <a:off x="1447635" y="2506133"/>
            <a:ext cx="0" cy="73348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oup 20">
            <a:extLst>
              <a:ext uri="{FF2B5EF4-FFF2-40B4-BE49-F238E27FC236}">
                <a16:creationId xmlns:a16="http://schemas.microsoft.com/office/drawing/2014/main" id="{80C6A8E0-ECF2-49E1-8058-DB4325CD23F0}"/>
              </a:ext>
            </a:extLst>
          </p:cNvPr>
          <p:cNvGrpSpPr/>
          <p:nvPr/>
        </p:nvGrpSpPr>
        <p:grpSpPr>
          <a:xfrm>
            <a:off x="664699" y="514963"/>
            <a:ext cx="11342996" cy="5828074"/>
            <a:chOff x="685965" y="554212"/>
            <a:chExt cx="11342996" cy="582807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43AC5C3-D175-4F5E-9D24-9F4141D3FC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85965" y="886952"/>
              <a:ext cx="1914462" cy="1963017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9C1BB24-D5A1-45B4-AAD5-1D3829C5057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21955" y="3093480"/>
              <a:ext cx="1878472" cy="196301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8D67C0E-F518-41CE-854B-255E481559E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32361" y="963307"/>
              <a:ext cx="1918057" cy="196301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FEF92C4-6667-4ADE-A11B-BB02089B88A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32360" y="3093480"/>
              <a:ext cx="1918057" cy="1963017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242CBCE-55F0-4D5A-B37D-289BCFDDF67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18363" y="963307"/>
              <a:ext cx="1918057" cy="196301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810C96A-0639-49BE-AD17-2B8EF926955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518363" y="3093480"/>
              <a:ext cx="1918057" cy="196301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36F9FA3-6E6B-41F0-B72F-47F15950479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934367" y="963307"/>
              <a:ext cx="1918057" cy="1963017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F5779E95-0A6C-4B86-88D0-140C922EC46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934367" y="3093480"/>
              <a:ext cx="1918057" cy="1963017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6BC19B6-2504-4525-90C7-0C22D1351567}"/>
                </a:ext>
              </a:extLst>
            </p:cNvPr>
            <p:cNvSpPr txBox="1"/>
            <p:nvPr/>
          </p:nvSpPr>
          <p:spPr>
            <a:xfrm>
              <a:off x="9964364" y="1733312"/>
              <a:ext cx="780001" cy="270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 Black" panose="020B0A04020102020204" pitchFamily="34" charset="0"/>
                </a:rPr>
                <a:t>T cell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8818FF3-F1D5-483D-8A17-C9E3C32A04E1}"/>
                </a:ext>
              </a:extLst>
            </p:cNvPr>
            <p:cNvSpPr txBox="1"/>
            <p:nvPr/>
          </p:nvSpPr>
          <p:spPr>
            <a:xfrm>
              <a:off x="9964364" y="3864871"/>
              <a:ext cx="780001" cy="270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 Black" panose="020B0A04020102020204" pitchFamily="34" charset="0"/>
                </a:rPr>
                <a:t>FMO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4CD9ADD-E113-47D7-8AE6-782B69DB7124}"/>
                </a:ext>
              </a:extLst>
            </p:cNvPr>
            <p:cNvSpPr txBox="1"/>
            <p:nvPr/>
          </p:nvSpPr>
          <p:spPr>
            <a:xfrm>
              <a:off x="721955" y="6012954"/>
              <a:ext cx="113070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 Black" panose="020B0A04020102020204" pitchFamily="34" charset="0"/>
                </a:rPr>
                <a:t>Supplement Fig.2A.  Strategy showing expression of PD-1, HLA-DR and CD123 on T cells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F4267DC4-245B-4900-A6D1-4135E9655F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56683" y="2377737"/>
              <a:ext cx="1127011" cy="184956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FB37B87-52C4-42CF-98B8-40BDCD17392A}"/>
                </a:ext>
              </a:extLst>
            </p:cNvPr>
            <p:cNvSpPr txBox="1"/>
            <p:nvPr/>
          </p:nvSpPr>
          <p:spPr>
            <a:xfrm>
              <a:off x="4091388" y="563356"/>
              <a:ext cx="69141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PD-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E805C17-5222-4AFD-9AEC-4CBE7EBEB4DF}"/>
                </a:ext>
              </a:extLst>
            </p:cNvPr>
            <p:cNvSpPr txBox="1"/>
            <p:nvPr/>
          </p:nvSpPr>
          <p:spPr>
            <a:xfrm>
              <a:off x="6096000" y="554212"/>
              <a:ext cx="11354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HLA-DR+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8C822B1-1882-49FA-BEB4-CB56ADDE6584}"/>
                </a:ext>
              </a:extLst>
            </p:cNvPr>
            <p:cNvSpPr txBox="1"/>
            <p:nvPr/>
          </p:nvSpPr>
          <p:spPr>
            <a:xfrm>
              <a:off x="8750808" y="563356"/>
              <a:ext cx="9875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CD12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894929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0E0C555C-83BD-4123-B7CA-10F3D555034F}"/>
              </a:ext>
            </a:extLst>
          </p:cNvPr>
          <p:cNvGrpSpPr/>
          <p:nvPr/>
        </p:nvGrpSpPr>
        <p:grpSpPr>
          <a:xfrm>
            <a:off x="410323" y="456714"/>
            <a:ext cx="10972800" cy="5853318"/>
            <a:chOff x="410323" y="456714"/>
            <a:chExt cx="10972800" cy="5853318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62C04C62-2283-40C0-8D66-9327A254A239}"/>
                </a:ext>
              </a:extLst>
            </p:cNvPr>
            <p:cNvGrpSpPr/>
            <p:nvPr/>
          </p:nvGrpSpPr>
          <p:grpSpPr>
            <a:xfrm>
              <a:off x="410323" y="809818"/>
              <a:ext cx="10972800" cy="5500214"/>
              <a:chOff x="410323" y="809818"/>
              <a:chExt cx="11620527" cy="5713938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643AC5C3-D175-4F5E-9D24-9F4141D3FC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10323" y="809818"/>
                <a:ext cx="2078088" cy="2011680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B9C1BB24-D5A1-45B4-AAD5-1D3829C505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49389" y="3065883"/>
                <a:ext cx="2039022" cy="2011680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6BC19B6-2504-4525-90C7-0C22D1351567}"/>
                  </a:ext>
                </a:extLst>
              </p:cNvPr>
              <p:cNvSpPr txBox="1"/>
              <p:nvPr/>
            </p:nvSpPr>
            <p:spPr>
              <a:xfrm>
                <a:off x="10659250" y="1654124"/>
                <a:ext cx="8466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B </a:t>
                </a:r>
                <a:r>
                  <a:rPr lang="en-US" sz="1200" dirty="0">
                    <a:latin typeface="Arial Black" panose="020B0A04020102020204" pitchFamily="34" charset="0"/>
                  </a:rPr>
                  <a:t>cells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8818FF3-F1D5-483D-8A17-C9E3C32A04E1}"/>
                  </a:ext>
                </a:extLst>
              </p:cNvPr>
              <p:cNvSpPr txBox="1"/>
              <p:nvPr/>
            </p:nvSpPr>
            <p:spPr>
              <a:xfrm>
                <a:off x="10659250" y="3856397"/>
                <a:ext cx="1371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 Black" panose="020B0A04020102020204" pitchFamily="34" charset="0"/>
                  </a:rPr>
                  <a:t>FMOs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24CD9ADD-E113-47D7-8AE6-782B69DB7124}"/>
                  </a:ext>
                </a:extLst>
              </p:cNvPr>
              <p:cNvSpPr txBox="1"/>
              <p:nvPr/>
            </p:nvSpPr>
            <p:spPr>
              <a:xfrm>
                <a:off x="1015039" y="6140073"/>
                <a:ext cx="10236090" cy="3836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Arial Black" panose="020B0A04020102020204" pitchFamily="34" charset="0"/>
                  </a:rPr>
                  <a:t>Fg.2B.  Strategy showing expression of PD-1, HLA-DR and CD123 on B cells</a:t>
                </a:r>
              </a:p>
            </p:txBody>
          </p:sp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C8ADD975-6699-4DE4-9590-5799B43AE27D}"/>
                  </a:ext>
                </a:extLst>
              </p:cNvPr>
              <p:cNvCxnSpPr>
                <a:endCxn id="3" idx="0"/>
              </p:cNvCxnSpPr>
              <p:nvPr/>
            </p:nvCxnSpPr>
            <p:spPr>
              <a:xfrm>
                <a:off x="1468900" y="2332397"/>
                <a:ext cx="0" cy="73348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F4267DC4-245B-4900-A6D1-4135E9655F1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468900" y="2273177"/>
                <a:ext cx="2039022" cy="145851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04873478-911E-4DEA-85C6-A393B0F0FB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215594" y="832950"/>
                <a:ext cx="2081991" cy="201168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7395287-315A-4142-A6CE-CCC5861E35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127549" y="3208959"/>
                <a:ext cx="2081991" cy="201168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58293467-F2ED-4B11-B28D-3EEB1824CE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849664" y="809818"/>
                <a:ext cx="2085057" cy="201168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CF5C1615-585E-4ADA-A49D-5FCF12419A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450525" y="832950"/>
                <a:ext cx="2085057" cy="201168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BEBF315D-0ABA-4D44-ABE2-396153F062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787011" y="3208959"/>
                <a:ext cx="2085057" cy="2011680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8BCA3622-7A95-4E5F-B6C4-2EC226F8FE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450525" y="3208959"/>
                <a:ext cx="2085057" cy="2011680"/>
              </a:xfrm>
              <a:prstGeom prst="rect">
                <a:avLst/>
              </a:prstGeom>
            </p:spPr>
          </p:pic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23A124D-50B3-4E81-A4BD-630CC7980C6C}"/>
                </a:ext>
              </a:extLst>
            </p:cNvPr>
            <p:cNvSpPr txBox="1"/>
            <p:nvPr/>
          </p:nvSpPr>
          <p:spPr>
            <a:xfrm>
              <a:off x="3922768" y="481383"/>
              <a:ext cx="920121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PD-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E9DBAC0-45DB-42F7-BF25-8489CAB65E10}"/>
                </a:ext>
              </a:extLst>
            </p:cNvPr>
            <p:cNvSpPr txBox="1"/>
            <p:nvPr/>
          </p:nvSpPr>
          <p:spPr>
            <a:xfrm>
              <a:off x="6182606" y="462753"/>
              <a:ext cx="1273545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HLA-DR+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AD622FE-3286-4CA5-B991-41FB53FF2911}"/>
                </a:ext>
              </a:extLst>
            </p:cNvPr>
            <p:cNvSpPr txBox="1"/>
            <p:nvPr/>
          </p:nvSpPr>
          <p:spPr>
            <a:xfrm>
              <a:off x="8664690" y="456714"/>
              <a:ext cx="116446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CD12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955166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BE878325-AE38-4F9F-B91B-5C2584DE02CB}"/>
              </a:ext>
            </a:extLst>
          </p:cNvPr>
          <p:cNvGrpSpPr/>
          <p:nvPr/>
        </p:nvGrpSpPr>
        <p:grpSpPr>
          <a:xfrm>
            <a:off x="332861" y="1006610"/>
            <a:ext cx="11232951" cy="5460351"/>
            <a:chOff x="332861" y="1006610"/>
            <a:chExt cx="11232951" cy="5460351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9A144FE-E571-4451-B4A8-ACA870883875}"/>
                </a:ext>
              </a:extLst>
            </p:cNvPr>
            <p:cNvSpPr txBox="1"/>
            <p:nvPr/>
          </p:nvSpPr>
          <p:spPr>
            <a:xfrm>
              <a:off x="3699399" y="1006610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PD-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58FE2C7-A9CD-44BD-8D6E-981E28522076}"/>
                </a:ext>
              </a:extLst>
            </p:cNvPr>
            <p:cNvSpPr txBox="1"/>
            <p:nvPr/>
          </p:nvSpPr>
          <p:spPr>
            <a:xfrm>
              <a:off x="5851301" y="1006610"/>
              <a:ext cx="9316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HLA-DR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054AF56-8952-44D3-88EF-8E95189CEAEE}"/>
                </a:ext>
              </a:extLst>
            </p:cNvPr>
            <p:cNvSpPr txBox="1"/>
            <p:nvPr/>
          </p:nvSpPr>
          <p:spPr>
            <a:xfrm>
              <a:off x="8280983" y="1006610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CD123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970506A-BA7D-4D42-B9AD-000900B0D16D}"/>
                </a:ext>
              </a:extLst>
            </p:cNvPr>
            <p:cNvSpPr txBox="1"/>
            <p:nvPr/>
          </p:nvSpPr>
          <p:spPr>
            <a:xfrm>
              <a:off x="9628313" y="2215174"/>
              <a:ext cx="13978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 Black" panose="020B0A04020102020204" pitchFamily="34" charset="0"/>
                </a:rPr>
                <a:t>Monocytes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5D82735-302C-4231-9465-4A8F8AB36604}"/>
                </a:ext>
              </a:extLst>
            </p:cNvPr>
            <p:cNvSpPr txBox="1"/>
            <p:nvPr/>
          </p:nvSpPr>
          <p:spPr>
            <a:xfrm>
              <a:off x="9628313" y="4387510"/>
              <a:ext cx="8114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 Black" panose="020B0A04020102020204" pitchFamily="34" charset="0"/>
                </a:rPr>
                <a:t>FMOs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07D2040-AC58-4C38-A82C-BC131523B65D}"/>
                </a:ext>
              </a:extLst>
            </p:cNvPr>
            <p:cNvSpPr txBox="1"/>
            <p:nvPr/>
          </p:nvSpPr>
          <p:spPr>
            <a:xfrm>
              <a:off x="868102" y="5943741"/>
              <a:ext cx="1069771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Supplement Fig. 3.  Strategy showing expression of  PD-1, HLA-DR and CD123 on Monocytes (CD3-CD14+)</a:t>
              </a:r>
            </a:p>
            <a:p>
              <a:r>
                <a:rPr lang="en-US" sz="1400" dirty="0">
                  <a:latin typeface="Arial Black" panose="020B0A04020102020204" pitchFamily="34" charset="0"/>
                </a:rPr>
                <a:t> 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1A14E9B-9CF9-4E9F-9772-028CEABFA8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2861" y="1247552"/>
              <a:ext cx="2078916" cy="2011854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5D4D34D-FCEC-421D-AC56-B0B01286444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8738" y="3525616"/>
              <a:ext cx="2042249" cy="201168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553D3897-3E27-4A33-A666-E166A8975F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02087" y="1240092"/>
              <a:ext cx="2085057" cy="201168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B33C62DA-C0EB-46FC-B9CB-E7FAF7A4166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722999" y="3533076"/>
              <a:ext cx="2085057" cy="201168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234D539-B126-4C9F-BF33-49EDC53CD06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077454" y="1240092"/>
              <a:ext cx="2085057" cy="201168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52BAD6C1-0E83-400A-B9CA-306CE3A0CF3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90068" y="3533076"/>
              <a:ext cx="2085057" cy="2011680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2D9F80BC-D532-4102-8075-9A10F2E82AD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452821" y="1240092"/>
              <a:ext cx="2085057" cy="201168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E7A4CDF5-8F74-4F90-B843-D5F38ADF903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452821" y="3533076"/>
              <a:ext cx="2085057" cy="2011680"/>
            </a:xfrm>
            <a:prstGeom prst="rect">
              <a:avLst/>
            </a:prstGeom>
          </p:spPr>
        </p:pic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5F7214C0-0952-4DE8-B4C3-7B9DC7C2E73C}"/>
                </a:ext>
              </a:extLst>
            </p:cNvPr>
            <p:cNvCxnSpPr/>
            <p:nvPr/>
          </p:nvCxnSpPr>
          <p:spPr>
            <a:xfrm>
              <a:off x="1792224" y="2368296"/>
              <a:ext cx="142646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533150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53B16D95-D7C9-47B0-9BBD-4BFB1CE4732A}"/>
              </a:ext>
            </a:extLst>
          </p:cNvPr>
          <p:cNvGrpSpPr/>
          <p:nvPr/>
        </p:nvGrpSpPr>
        <p:grpSpPr>
          <a:xfrm>
            <a:off x="301751" y="1043186"/>
            <a:ext cx="11493299" cy="5281343"/>
            <a:chOff x="301751" y="1043186"/>
            <a:chExt cx="11493299" cy="528134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9A144FE-E571-4451-B4A8-ACA870883875}"/>
                </a:ext>
              </a:extLst>
            </p:cNvPr>
            <p:cNvSpPr txBox="1"/>
            <p:nvPr/>
          </p:nvSpPr>
          <p:spPr>
            <a:xfrm>
              <a:off x="3699399" y="1043186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PD-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58FE2C7-A9CD-44BD-8D6E-981E28522076}"/>
                </a:ext>
              </a:extLst>
            </p:cNvPr>
            <p:cNvSpPr txBox="1"/>
            <p:nvPr/>
          </p:nvSpPr>
          <p:spPr>
            <a:xfrm>
              <a:off x="5851301" y="1043186"/>
              <a:ext cx="9316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HLA-DR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054AF56-8952-44D3-88EF-8E95189CEAEE}"/>
                </a:ext>
              </a:extLst>
            </p:cNvPr>
            <p:cNvSpPr txBox="1"/>
            <p:nvPr/>
          </p:nvSpPr>
          <p:spPr>
            <a:xfrm>
              <a:off x="8280983" y="1043186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CD123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970506A-BA7D-4D42-B9AD-000900B0D16D}"/>
                </a:ext>
              </a:extLst>
            </p:cNvPr>
            <p:cNvSpPr txBox="1"/>
            <p:nvPr/>
          </p:nvSpPr>
          <p:spPr>
            <a:xfrm>
              <a:off x="9628313" y="2251750"/>
              <a:ext cx="8947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 Black" panose="020B0A04020102020204" pitchFamily="34" charset="0"/>
                </a:rPr>
                <a:t>NK cells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5D82735-302C-4231-9465-4A8F8AB36604}"/>
                </a:ext>
              </a:extLst>
            </p:cNvPr>
            <p:cNvSpPr txBox="1"/>
            <p:nvPr/>
          </p:nvSpPr>
          <p:spPr>
            <a:xfrm>
              <a:off x="9628313" y="4424086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 Black" panose="020B0A04020102020204" pitchFamily="34" charset="0"/>
                </a:rPr>
                <a:t>FMOs</a:t>
              </a:r>
            </a:p>
          </p:txBody>
        </p: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63C22ADD-543E-4920-9CF7-1D3CB13994B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7826" y="2636837"/>
              <a:ext cx="2042249" cy="201168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5AE3A757-F8D4-47E6-B913-9E3D8C982B5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91631" y="3602912"/>
              <a:ext cx="2085057" cy="2011680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2ED1D68E-7963-49B1-A3C4-A5467C448DF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48246" y="1276668"/>
              <a:ext cx="2085057" cy="201168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4A2E6435-66D6-4663-AFE7-0B0F196D572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48244" y="3602912"/>
              <a:ext cx="2085057" cy="2011680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1D41866C-8D96-4BE8-B1B2-7EB82A4ED91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415313" y="1276668"/>
              <a:ext cx="2085057" cy="2011680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DAF4048D-8B05-468E-9BBC-BF17C3BFE58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415313" y="3602912"/>
              <a:ext cx="2085057" cy="2011680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07D2040-AC58-4C38-A82C-BC131523B65D}"/>
                </a:ext>
              </a:extLst>
            </p:cNvPr>
            <p:cNvSpPr txBox="1"/>
            <p:nvPr/>
          </p:nvSpPr>
          <p:spPr>
            <a:xfrm>
              <a:off x="301751" y="6016752"/>
              <a:ext cx="114932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 Black" panose="020B0A04020102020204" pitchFamily="34" charset="0"/>
                </a:rPr>
                <a:t>Supplement Fg.4.  Strategy showing expression of  PD-1, HLA-DR and CD123 on NK (CD3-CD16+) cells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DFBA201-F6CE-49C4-857F-FE7A807AA80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702085" y="1276668"/>
              <a:ext cx="2085057" cy="2011680"/>
            </a:xfrm>
            <a:prstGeom prst="rect">
              <a:avLst/>
            </a:prstGeom>
          </p:spPr>
        </p:pic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DF37412C-C75D-4301-82CB-CC1EFF2FD6E1}"/>
                </a:ext>
              </a:extLst>
            </p:cNvPr>
            <p:cNvCxnSpPr/>
            <p:nvPr/>
          </p:nvCxnSpPr>
          <p:spPr>
            <a:xfrm flipV="1">
              <a:off x="1243584" y="2528749"/>
              <a:ext cx="1883664" cy="68079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349097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9A144FE-E571-4451-B4A8-ACA870883875}"/>
              </a:ext>
            </a:extLst>
          </p:cNvPr>
          <p:cNvSpPr txBox="1"/>
          <p:nvPr/>
        </p:nvSpPr>
        <p:spPr>
          <a:xfrm>
            <a:off x="3693850" y="126935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 Black" panose="020B0A04020102020204" pitchFamily="34" charset="0"/>
              </a:rPr>
              <a:t>PD-1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A2B895F3-593E-408F-AA69-14A4CE09CD75}"/>
              </a:ext>
            </a:extLst>
          </p:cNvPr>
          <p:cNvGrpSpPr/>
          <p:nvPr/>
        </p:nvGrpSpPr>
        <p:grpSpPr>
          <a:xfrm>
            <a:off x="203040" y="119653"/>
            <a:ext cx="12042132" cy="6523747"/>
            <a:chOff x="203040" y="119653"/>
            <a:chExt cx="12042132" cy="6523747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58FE2C7-A9CD-44BD-8D6E-981E28522076}"/>
                </a:ext>
              </a:extLst>
            </p:cNvPr>
            <p:cNvSpPr txBox="1"/>
            <p:nvPr/>
          </p:nvSpPr>
          <p:spPr>
            <a:xfrm>
              <a:off x="5785173" y="119653"/>
              <a:ext cx="9316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HLA-DR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054AF56-8952-44D3-88EF-8E95189CEAEE}"/>
                </a:ext>
              </a:extLst>
            </p:cNvPr>
            <p:cNvSpPr txBox="1"/>
            <p:nvPr/>
          </p:nvSpPr>
          <p:spPr>
            <a:xfrm>
              <a:off x="8214855" y="119653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CD123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970506A-BA7D-4D42-B9AD-000900B0D16D}"/>
                </a:ext>
              </a:extLst>
            </p:cNvPr>
            <p:cNvSpPr txBox="1"/>
            <p:nvPr/>
          </p:nvSpPr>
          <p:spPr>
            <a:xfrm>
              <a:off x="9471168" y="1351540"/>
              <a:ext cx="22157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Classical monocytes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07D2040-AC58-4C38-A82C-BC131523B65D}"/>
                </a:ext>
              </a:extLst>
            </p:cNvPr>
            <p:cNvSpPr txBox="1"/>
            <p:nvPr/>
          </p:nvSpPr>
          <p:spPr>
            <a:xfrm>
              <a:off x="203040" y="5558210"/>
              <a:ext cx="218757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 Black" panose="020B0A04020102020204" pitchFamily="34" charset="0"/>
                </a:rPr>
                <a:t>Supplement Fg.5.  Strategy showing expression of  PD-1, HLA-DR and CD123 on Monocytes 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1A14E9B-9CF9-4E9F-9772-028CEABFA8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6733" y="339330"/>
              <a:ext cx="2078916" cy="2011854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35150D8-ED12-4243-A285-95E6FD56B900}"/>
                </a:ext>
              </a:extLst>
            </p:cNvPr>
            <p:cNvSpPr txBox="1"/>
            <p:nvPr/>
          </p:nvSpPr>
          <p:spPr>
            <a:xfrm>
              <a:off x="9471750" y="3381767"/>
              <a:ext cx="26541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Intermediate monocytes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B7351EE-D9E1-4CE4-A89E-44AD1A274EFC}"/>
                </a:ext>
              </a:extLst>
            </p:cNvPr>
            <p:cNvSpPr txBox="1"/>
            <p:nvPr/>
          </p:nvSpPr>
          <p:spPr>
            <a:xfrm>
              <a:off x="9591051" y="5198683"/>
              <a:ext cx="26541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 Black" panose="020B0A04020102020204" pitchFamily="34" charset="0"/>
                </a:rPr>
                <a:t>Non-classical monocytes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E6646CC-3726-4F9E-AB97-29342C02D32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3400" y="2531819"/>
              <a:ext cx="2042249" cy="201168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0F86A57-8100-44E9-9A49-F4C498AF360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651322" y="360595"/>
              <a:ext cx="2085057" cy="201168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F565D3B-B3CA-4AEE-A3CE-C434DD61A7A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57109" y="2531819"/>
              <a:ext cx="2085057" cy="201168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57E06244-3CC3-43FD-98E4-98BDA844996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51321" y="4631720"/>
              <a:ext cx="2085057" cy="2011680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26F852AF-2807-4744-A750-4C9F46B449D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42052" y="360769"/>
              <a:ext cx="2085057" cy="2011680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33FB7B01-5A84-49C1-8D3D-181692E740B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53626" y="2531819"/>
              <a:ext cx="2085057" cy="201168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F31B4BC5-892A-48FC-82DB-A35D271C3B9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048368" y="4623705"/>
              <a:ext cx="2085057" cy="2011680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3F9D8DE1-770D-49A3-918A-534523AC846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386682" y="360769"/>
              <a:ext cx="2085057" cy="2011680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58973383-22C4-4EF1-A976-E7FCE9F8C53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386682" y="2531819"/>
              <a:ext cx="2085057" cy="2011680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64DFE3C9-0BEE-49DA-8F9A-84D2B1BA4F0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7505994" y="4631720"/>
              <a:ext cx="2085057" cy="2011680"/>
            </a:xfrm>
            <a:prstGeom prst="rect">
              <a:avLst/>
            </a:prstGeom>
          </p:spPr>
        </p:pic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D744072D-4463-4110-BEFE-02C9CF441DD9}"/>
                </a:ext>
              </a:extLst>
            </p:cNvPr>
            <p:cNvCxnSpPr>
              <a:cxnSpLocks/>
            </p:cNvCxnSpPr>
            <p:nvPr/>
          </p:nvCxnSpPr>
          <p:spPr>
            <a:xfrm>
              <a:off x="1777420" y="1546412"/>
              <a:ext cx="0" cy="109138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99297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8</TotalTime>
  <Words>145</Words>
  <Application>Microsoft Office PowerPoint</Application>
  <PresentationFormat>Widescreen</PresentationFormat>
  <Paragraphs>3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Arial Black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hete,Pramod N</dc:creator>
  <cp:lastModifiedBy>Nehete,Pramod N</cp:lastModifiedBy>
  <cp:revision>91</cp:revision>
  <cp:lastPrinted>2023-09-01T21:47:51Z</cp:lastPrinted>
  <dcterms:created xsi:type="dcterms:W3CDTF">2023-08-21T20:24:19Z</dcterms:created>
  <dcterms:modified xsi:type="dcterms:W3CDTF">2024-02-19T16:22:09Z</dcterms:modified>
</cp:coreProperties>
</file>